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b-NO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57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4CE24F-8618-4E04-8AEE-30E9408A2C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3FF60F3-B4EF-4DC3-925D-B0118586BD4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854050-D166-4E38-B8EC-0D0BD5CC50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228A8-FF19-4A06-A8B0-0774C9853CB8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31F09C-2767-4233-87AF-1C5A9B5719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864A36-44BD-4963-8E0D-BCB3C85573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00F33-2CBB-4CA5-B6C9-865D1CAC14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753127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E58173-044F-4B21-9DCA-4A9F7F9D31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327CABA-878E-463C-8AD4-C53F5612050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8A990E6-1ED6-427F-A70D-36C52E3166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228A8-FF19-4A06-A8B0-0774C9853CB8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4E2C299-5206-49B0-BC37-B0E30223AA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B620AD-E1E2-4BAF-8301-6979952025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00F33-2CBB-4CA5-B6C9-865D1CAC14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101846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FE9F9F-D2B7-47A6-846F-BBA1E70257D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2618D8A-153A-4E42-AE12-05D64A8BA0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1051C1-1641-432F-B131-F612891A10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228A8-FF19-4A06-A8B0-0774C9853CB8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E76F85-7909-4491-83AC-7BC5992473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EC1E6C-6619-4973-812A-B246E49B3C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00F33-2CBB-4CA5-B6C9-865D1CAC14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919661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172C4C-758E-4434-ABC6-937A245115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521001-2AED-48FC-8FB7-2B034D6522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2BA24B2-8210-4016-813C-599708EBC3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228A8-FF19-4A06-A8B0-0774C9853CB8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3A863C7-8519-43B1-A2DA-4D0F28A704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EE1DD5-2BC8-4354-A822-CCBFAA465B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00F33-2CBB-4CA5-B6C9-865D1CAC14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509751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A5E5BB-6948-4C95-AF7B-DE7F8D70EB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811595-3D21-4A99-857B-5BAE157C10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BF3A32-5029-458E-95A0-6198D72022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228A8-FF19-4A06-A8B0-0774C9853CB8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57A8EB-CE0A-46A8-84DA-D16D10EE9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07E995-5531-4D88-B8F5-F3C1D9C456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00F33-2CBB-4CA5-B6C9-865D1CAC14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875809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DC1B28-F642-456F-91AF-FA1BCFBF9E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7D2522-0A57-48E7-8DBE-23F96668503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AB6700-8F94-4710-AB6D-C2354D0079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EA0531-3796-4434-864B-70CE3423A1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228A8-FF19-4A06-A8B0-0774C9853CB8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F35B1C-E156-484A-A891-4F9BC95DC3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9ADBF3-2C1A-405C-B1AF-AB1FC1E6C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00F33-2CBB-4CA5-B6C9-865D1CAC14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677632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B5AC43-4090-45B4-9841-794CF810D9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B748C9-B646-433D-8C48-0C73F6AE00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F25CBE-4560-40DC-A64C-1DB266C7AE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683DA3A-5F4C-4BC0-930A-B161D16B68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FFC5D77-B9B7-4D09-A2FD-FA6CF7E687C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C51FF4B-2016-4A6B-9798-303A0A68C2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228A8-FF19-4A06-A8B0-0774C9853CB8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8A87D26-EDC6-4EE8-A0C9-889D2DA15C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B4D46A5-59D3-48AE-88C7-2F80C9EEAF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00F33-2CBB-4CA5-B6C9-865D1CAC14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377631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02E169-71BB-47B9-903E-99156F7F74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C52B83C-7158-4A8C-820E-4555328FC1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228A8-FF19-4A06-A8B0-0774C9853CB8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09B586E-7DC5-4260-A0A8-5FF6466B50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B15E709-2945-4CB0-B8C3-D0381BEE24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00F33-2CBB-4CA5-B6C9-865D1CAC14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1223650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0F1A3C-F1C7-4743-B55E-57E5838214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228A8-FF19-4A06-A8B0-0774C9853CB8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272A775-F8BC-4F44-B024-1BA550A881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D92B95D-37EA-4653-9C09-02E4C46188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00F33-2CBB-4CA5-B6C9-865D1CAC14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536815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205DDD-A799-417A-B855-15CA883881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9A7F51B-DA19-4835-A604-599584BEDC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32B5FE-1466-4636-A9A0-5979616601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C25E6C-53F4-47B2-B73B-A26A9DC877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228A8-FF19-4A06-A8B0-0774C9853CB8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8884A1-9932-4DE8-B902-3AF726523E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C54F806-A17C-4B9E-A4D4-A415442BD3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00F33-2CBB-4CA5-B6C9-865D1CAC14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4284196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586967-FBE6-4465-B706-AF02CB9EA8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559F251-D482-4D70-8B61-E42282541B5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b-NO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2D4F815-BCFF-4C33-848A-6EA0DB4857F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E51DDA-C1C5-4060-92DE-D8DE5626CC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228A8-FF19-4A06-A8B0-0774C9853CB8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DB7FD4-8D05-4595-9975-F53B83A448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738568-5736-4133-AB38-2E11C61859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A00F33-2CBB-4CA5-B6C9-865D1CAC14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817648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5F015E4-0972-4359-97FD-5485F660CC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nb-NO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B55BB1-4F71-4405-996D-C4DD0A7B2D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nb-NO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8D8976-F620-4AB8-9933-41D488A8C4A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1228A8-FF19-4A06-A8B0-0774C9853CB8}" type="datetimeFigureOut">
              <a:rPr lang="nb-NO" smtClean="0"/>
              <a:t>17.02.2021</a:t>
            </a:fld>
            <a:endParaRPr lang="nb-NO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2B8807-5B11-4389-9ABC-48567BED77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8E1245-AF49-4154-8018-7C7D3D1F7F7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A00F33-2CBB-4CA5-B6C9-865D1CAC1447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68580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NO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microreact.org/project/ghVerc4vJENwTkHtgZURd1/0d5dcd3d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835A4E9-01E6-4E3B-9966-CF316CB41D6E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3077" y="477883"/>
            <a:ext cx="5878830" cy="3672840"/>
          </a:xfrm>
          <a:prstGeom prst="rect">
            <a:avLst/>
          </a:prstGeom>
          <a:noFill/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88FD651C-BBA0-49ED-880E-F63729D6D6A2}"/>
              </a:ext>
            </a:extLst>
          </p:cNvPr>
          <p:cNvSpPr/>
          <p:nvPr/>
        </p:nvSpPr>
        <p:spPr>
          <a:xfrm>
            <a:off x="2734492" y="4793512"/>
            <a:ext cx="6096000" cy="1015663"/>
          </a:xfrm>
          <a:prstGeom prst="rect">
            <a:avLst/>
          </a:prstGeom>
        </p:spPr>
        <p:txBody>
          <a:bodyPr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S3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Serotype O111 (n=43) core SNP based phylogenetic tree generated by Snippy v. 4.6.0 (https://github.com/tseemann/snippy) and recombination removal with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ubbin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 2.4.1. The resulting recombination free core SNP alignment was used to construct high-resolution phylogeny with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stTree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v. 2.1.9. An interactive version of the tree is available at </a:t>
            </a:r>
            <a:r>
              <a:rPr lang="en-US" sz="1200" u="sng" dirty="0">
                <a:solidFill>
                  <a:srgbClr val="0000FF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microreact.org/project/ghVerc4vJENwTkHtgZURd1/0d5dcd3d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nb-NO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38694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ril Lindbäck</dc:creator>
  <cp:lastModifiedBy>Toril Lindbäck</cp:lastModifiedBy>
  <cp:revision>1</cp:revision>
  <dcterms:created xsi:type="dcterms:W3CDTF">2021-02-17T12:53:39Z</dcterms:created>
  <dcterms:modified xsi:type="dcterms:W3CDTF">2021-02-17T12:54:4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0484126-3486-41a9-802e-7f1e2277276c_Enabled">
    <vt:lpwstr>True</vt:lpwstr>
  </property>
  <property fmtid="{D5CDD505-2E9C-101B-9397-08002B2CF9AE}" pid="3" name="MSIP_Label_d0484126-3486-41a9-802e-7f1e2277276c_SiteId">
    <vt:lpwstr>eec01f8e-737f-43e3-9ed5-f8a59913bd82</vt:lpwstr>
  </property>
  <property fmtid="{D5CDD505-2E9C-101B-9397-08002B2CF9AE}" pid="4" name="MSIP_Label_d0484126-3486-41a9-802e-7f1e2277276c_Owner">
    <vt:lpwstr>toril.lindback@nmbu.no</vt:lpwstr>
  </property>
  <property fmtid="{D5CDD505-2E9C-101B-9397-08002B2CF9AE}" pid="5" name="MSIP_Label_d0484126-3486-41a9-802e-7f1e2277276c_SetDate">
    <vt:lpwstr>2021-02-17T12:54:42.7184877Z</vt:lpwstr>
  </property>
  <property fmtid="{D5CDD505-2E9C-101B-9397-08002B2CF9AE}" pid="6" name="MSIP_Label_d0484126-3486-41a9-802e-7f1e2277276c_Name">
    <vt:lpwstr>Internal</vt:lpwstr>
  </property>
  <property fmtid="{D5CDD505-2E9C-101B-9397-08002B2CF9AE}" pid="7" name="MSIP_Label_d0484126-3486-41a9-802e-7f1e2277276c_Application">
    <vt:lpwstr>Microsoft Azure Information Protection</vt:lpwstr>
  </property>
  <property fmtid="{D5CDD505-2E9C-101B-9397-08002B2CF9AE}" pid="8" name="MSIP_Label_d0484126-3486-41a9-802e-7f1e2277276c_ActionId">
    <vt:lpwstr>5fe951dc-7c6b-4922-8397-3b20e92f28ea</vt:lpwstr>
  </property>
  <property fmtid="{D5CDD505-2E9C-101B-9397-08002B2CF9AE}" pid="9" name="MSIP_Label_d0484126-3486-41a9-802e-7f1e2277276c_Extended_MSFT_Method">
    <vt:lpwstr>Automatic</vt:lpwstr>
  </property>
  <property fmtid="{D5CDD505-2E9C-101B-9397-08002B2CF9AE}" pid="10" name="Sensitivity">
    <vt:lpwstr>Internal</vt:lpwstr>
  </property>
</Properties>
</file>